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4FEC8B-8C4B-4EFA-A195-74FBA25444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F2D5EB3-2FD2-4F85-8D42-30EA49BCDF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E14C94-68EC-4E57-B5E7-B596449C4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7156B1-86A3-4E67-A9D3-DCD21419A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88BCBE-157B-4E7F-B80E-CBD465510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679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F83080-1475-4670-A568-ED3FEF61CE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BB576D6-5314-46FD-A2BD-67DD796914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3CCFEF-0431-436A-B09F-8157988FA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2455DA-0C94-42CF-8428-88C1A67F5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3D60FD-90C9-42BA-B82D-F5D74E499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7229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0BD91D2-1975-4087-B84F-20942BDD99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AB31851-7DF0-4770-92FC-74DF1DB516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CCB89E-B13B-46C3-B244-B95314FAA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95B3D83-B816-4408-8D71-7B9C1CF12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FEC024-AEB1-4B36-9A61-71AA59FDA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370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092BA6-7814-4546-A11B-88B8E9803C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1E5E24-84A9-4064-9346-4863DF6E84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37E1C2-018A-4E04-9EF9-ABA9F7E10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71161A-DB71-48B8-932F-153283988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2A86D9-12C9-48DE-AB65-511101493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0483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DF8B7A-1F72-4AE3-BA35-3022B36802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4DE57E-205F-4A0C-A4D0-D7CEE0E7A5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CA6EDA-F074-4983-9AF4-DF628DD68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E09AD8-3A96-4C93-98CD-8C0833E02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649931-1626-419B-A232-9F03170FA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12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EC4B32-2F39-4AD0-84D7-ECAAE4C162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361475-0C8C-4F8E-9ED8-D3C0146475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C77CBB8-A6B7-4117-8641-AD4AB6FE81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F6519D4-A79F-418A-AFDF-9E8E364C7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E1D34EB-B4F0-4BDF-95FD-AC36AB160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B432D6-0812-4AD5-81A1-E5EC2E9BD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999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59E94F-C5D1-4953-98D5-3143A999E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9C2B5E9-BE7C-4AE2-8098-0C41DC1C44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A1FE7C0-38B3-483A-9868-4622BA64D4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2A3CCAB-B3EE-4C7B-A600-77733EA145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140B9A5-22ED-47D0-BD8B-55333E9FC5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B0F1937-D9A8-4E80-8C00-CB026EEFC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10C3F9D-83D0-406D-88F3-C67E11DCE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4F4AF00-0536-437C-9A7F-1279FC7D5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8653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06CFEA-87F0-471B-9845-85C614CE22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E60C98B-D48A-42B3-8ED5-964E3DC6A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E1558A7-3BE3-4D21-8E0A-13793F6DB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B7B974B-28B0-4527-BFEB-9A0659D70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9200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ECF02DE-9AD0-4CCB-AD24-DF8B223B5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1C97E8E-D10E-49C5-8097-CC65F8B09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7D18387-C970-488F-BB14-4F3E23DE7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0292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8907BD-8D9A-42BF-BD2F-D57CA41EAE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3AF6E71-92E3-4702-A06F-22F534787F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60143A2-1654-418A-AFEE-1D865B70BE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BCA66F-F8EC-4182-BB03-9C78FC7BB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66AE69-9867-4D2E-BFDF-4157AF6B2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079B4A-B18B-49A1-AEF9-34A80CE17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3914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5185F7-F699-4BCD-9D0F-51C9BA6BF0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73E5C44-95C5-4AFF-819C-96E0CAA43C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FFF9AC0-0A01-49DA-9828-CF4B72377F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36CB7F-E443-4266-B1DF-84428AF0A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E039EA8-F5F4-4682-A590-CD09DFF77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5F7ADA3-CF99-48B1-AAAF-90C486B34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8034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009F71A-E2DC-4ADA-9345-5CFF45928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4E430C1-FB09-488C-BB9F-14753B99B9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5720B0-4A6F-4F24-BC19-834B8BE234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F783EB-E5FE-47FA-9F65-2B7A4EA346AD}" type="datetimeFigureOut">
              <a:rPr lang="zh-CN" altLang="en-US" smtClean="0"/>
              <a:t>2024/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DBCE2F-DDE7-4EA8-8275-293FA55A91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9E7756-0693-49E2-8318-3AB46BC7EA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77C99-0F40-4CD1-BF65-6EE0F2E83A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5335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78B3B62-28A6-4A0D-9FA3-3D89D79F1F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5282"/>
            <a:ext cx="12192000" cy="546743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BA31253-4B5B-4C3D-893D-C7B9DB2FAB5C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689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E76E655-A89E-4040-B7FE-2E5FFAC19D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1098" y="480766"/>
            <a:ext cx="9565850" cy="637723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996A76F-91E2-4BBE-8111-88EC2FC093BF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6939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B7D0FDF-4E76-4EEA-9C19-8CD602A2B2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207" y="294861"/>
            <a:ext cx="8021218" cy="656313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9F079BD-A723-48D2-BA2C-F3EF9AE73FF8}"/>
              </a:ext>
            </a:extLst>
          </p:cNvPr>
          <p:cNvSpPr txBox="1"/>
          <p:nvPr/>
        </p:nvSpPr>
        <p:spPr>
          <a:xfrm>
            <a:off x="566601" y="179109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62884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69CEE02-A3F0-4810-88B6-EFAB6D2DAE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81490"/>
            <a:ext cx="12192000" cy="569501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1DEE370-64B2-4BD8-AAEA-A361F19FCE84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55951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B12859C-D146-4AEF-9D85-D075F8CB5B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3060" y="616187"/>
            <a:ext cx="9566812" cy="624181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054D507-93DF-45F5-84F3-C46D1C593E7B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88974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EC7E2D4-AD99-4C32-B179-02C058DE80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8213" y="659920"/>
            <a:ext cx="10261722" cy="619808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FFBDE45-B473-4763-8EDA-FDB091B20F35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60152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4E6E9E9-237C-489D-8CB4-FB2DBE3A19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44786"/>
            <a:ext cx="12192000" cy="476842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224130E-B756-4085-9110-65D0BCDABB5A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47005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B291BD7-5AAE-4BE9-8FF2-2265A67ECC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736" y="605002"/>
            <a:ext cx="8201351" cy="607993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2B76929-4A7C-470F-A253-C35757C4CF07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284E497-0A25-4B8E-AD77-B4E97A8CF93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8" t="46385" r="33580" b="47188"/>
          <a:stretch/>
        </p:blipFill>
        <p:spPr>
          <a:xfrm>
            <a:off x="7725384" y="5683451"/>
            <a:ext cx="1817632" cy="21131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7A97624-7AFB-440E-838C-AF46EF6A317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50" t="47073" r="34221" b="47187"/>
          <a:stretch/>
        </p:blipFill>
        <p:spPr>
          <a:xfrm>
            <a:off x="7725384" y="5383219"/>
            <a:ext cx="1856607" cy="21131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5D38E56-08D2-404C-B10C-77F23515744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29" t="47074" r="33901" b="46958"/>
          <a:stretch/>
        </p:blipFill>
        <p:spPr>
          <a:xfrm>
            <a:off x="7725384" y="5082987"/>
            <a:ext cx="1817633" cy="211311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31B7F4E2-62C6-4FD3-828C-16BD9690C76A}"/>
              </a:ext>
            </a:extLst>
          </p:cNvPr>
          <p:cNvSpPr/>
          <p:nvPr/>
        </p:nvSpPr>
        <p:spPr>
          <a:xfrm>
            <a:off x="7714216" y="5082987"/>
            <a:ext cx="1828801" cy="2113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5280C85B-E816-4C95-912E-C0D512B76CCB}"/>
              </a:ext>
            </a:extLst>
          </p:cNvPr>
          <p:cNvSpPr/>
          <p:nvPr/>
        </p:nvSpPr>
        <p:spPr>
          <a:xfrm>
            <a:off x="7714216" y="5383219"/>
            <a:ext cx="1828801" cy="2113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6A6C156E-B259-47CE-AE29-4B89DA8D283D}"/>
              </a:ext>
            </a:extLst>
          </p:cNvPr>
          <p:cNvSpPr/>
          <p:nvPr/>
        </p:nvSpPr>
        <p:spPr>
          <a:xfrm>
            <a:off x="7714215" y="5683451"/>
            <a:ext cx="1828801" cy="2113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5707B04-A0AA-46B4-9CC5-6219EADC484A}"/>
              </a:ext>
            </a:extLst>
          </p:cNvPr>
          <p:cNvSpPr txBox="1"/>
          <p:nvPr/>
        </p:nvSpPr>
        <p:spPr>
          <a:xfrm>
            <a:off x="7192254" y="5894762"/>
            <a:ext cx="6454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IL1-β</a:t>
            </a:r>
          </a:p>
          <a:p>
            <a:pPr algn="ctr"/>
            <a:r>
              <a: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ng/ml</a:t>
            </a:r>
            <a:r>
              <a: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DC8733F-7FCD-4365-B308-2D98FC996B28}"/>
              </a:ext>
            </a:extLst>
          </p:cNvPr>
          <p:cNvSpPr txBox="1"/>
          <p:nvPr/>
        </p:nvSpPr>
        <p:spPr>
          <a:xfrm>
            <a:off x="7808087" y="5894762"/>
            <a:ext cx="2344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16BD29F-8948-4F0C-BAB4-FBDB1661581B}"/>
              </a:ext>
            </a:extLst>
          </p:cNvPr>
          <p:cNvSpPr txBox="1"/>
          <p:nvPr/>
        </p:nvSpPr>
        <p:spPr>
          <a:xfrm>
            <a:off x="8039101" y="5898432"/>
            <a:ext cx="370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8102745-B5B3-4CD7-B59E-54608FA9C74B}"/>
              </a:ext>
            </a:extLst>
          </p:cNvPr>
          <p:cNvSpPr txBox="1"/>
          <p:nvPr/>
        </p:nvSpPr>
        <p:spPr>
          <a:xfrm>
            <a:off x="8362900" y="5894762"/>
            <a:ext cx="2344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38C1234-3586-4DAB-B626-69D73F68DDD4}"/>
              </a:ext>
            </a:extLst>
          </p:cNvPr>
          <p:cNvSpPr txBox="1"/>
          <p:nvPr/>
        </p:nvSpPr>
        <p:spPr>
          <a:xfrm>
            <a:off x="8588334" y="5894762"/>
            <a:ext cx="3603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CB6B098-2503-4B68-90C4-F6790EBDA98D}"/>
              </a:ext>
            </a:extLst>
          </p:cNvPr>
          <p:cNvSpPr txBox="1"/>
          <p:nvPr/>
        </p:nvSpPr>
        <p:spPr>
          <a:xfrm>
            <a:off x="8871608" y="5894758"/>
            <a:ext cx="3802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5FA3081-EC36-43C8-A70A-E566A793BDF0}"/>
              </a:ext>
            </a:extLst>
          </p:cNvPr>
          <p:cNvSpPr txBox="1"/>
          <p:nvPr/>
        </p:nvSpPr>
        <p:spPr>
          <a:xfrm>
            <a:off x="9178416" y="5894758"/>
            <a:ext cx="333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CF71FEA-E3F1-40E9-BF55-53D5FE215EC0}"/>
              </a:ext>
            </a:extLst>
          </p:cNvPr>
          <p:cNvSpPr txBox="1"/>
          <p:nvPr/>
        </p:nvSpPr>
        <p:spPr>
          <a:xfrm>
            <a:off x="7192253" y="5086635"/>
            <a:ext cx="645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X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E144F00-D916-4760-9A81-6884C40731F6}"/>
              </a:ext>
            </a:extLst>
          </p:cNvPr>
          <p:cNvSpPr txBox="1"/>
          <p:nvPr/>
        </p:nvSpPr>
        <p:spPr>
          <a:xfrm>
            <a:off x="7190973" y="5391000"/>
            <a:ext cx="645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MMP1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815CF0B-44D8-4C93-A905-21AB88A3B537}"/>
              </a:ext>
            </a:extLst>
          </p:cNvPr>
          <p:cNvSpPr txBox="1"/>
          <p:nvPr/>
        </p:nvSpPr>
        <p:spPr>
          <a:xfrm>
            <a:off x="7179240" y="5681385"/>
            <a:ext cx="645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61850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18298B1-49B5-40AB-A628-71C0119EB58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793" b="48179"/>
          <a:stretch/>
        </p:blipFill>
        <p:spPr>
          <a:xfrm>
            <a:off x="1093440" y="1489435"/>
            <a:ext cx="10005120" cy="462856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392E305-9CF0-4CBF-BCA4-5A630CC86BAD}"/>
              </a:ext>
            </a:extLst>
          </p:cNvPr>
          <p:cNvSpPr txBox="1"/>
          <p:nvPr/>
        </p:nvSpPr>
        <p:spPr>
          <a:xfrm>
            <a:off x="631597" y="235670"/>
            <a:ext cx="1338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13FFF5D-3323-46B0-BC14-969C7A8939FF}"/>
              </a:ext>
            </a:extLst>
          </p:cNvPr>
          <p:cNvSpPr txBox="1"/>
          <p:nvPr/>
        </p:nvSpPr>
        <p:spPr>
          <a:xfrm>
            <a:off x="631597" y="900259"/>
            <a:ext cx="7890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he immunohistochemical results of negative control were adde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4644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1</Words>
  <Application>Microsoft Office PowerPoint</Application>
  <PresentationFormat>宽屏</PresentationFormat>
  <Paragraphs>21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</dc:creator>
  <cp:lastModifiedBy>MI</cp:lastModifiedBy>
  <cp:revision>4</cp:revision>
  <dcterms:created xsi:type="dcterms:W3CDTF">2024-01-12T09:32:46Z</dcterms:created>
  <dcterms:modified xsi:type="dcterms:W3CDTF">2024-01-12T11:35:03Z</dcterms:modified>
</cp:coreProperties>
</file>